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97" d="100"/>
          <a:sy n="97" d="100"/>
        </p:scale>
        <p:origin x="90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670F4F-8B30-4B3E-A091-65BAE8BD00FC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AC111E-58F8-4072-8E83-BB88A240A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799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Caption. Individual responses for the C_IS score and corresponding individual’s response for each component that comprises the C_IS sco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6BDAFE-E6C8-4EBA-A01A-714A9B902A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646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256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125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407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942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587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582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776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451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74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23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55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94F7E-A90E-4DEA-A6D4-4D3BA90851FD}" type="datetimeFigureOut">
              <a:rPr lang="en-US" smtClean="0"/>
              <a:t>7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701C7-148A-42EE-BBB6-1BA5F2BA33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687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C7B4E844-33ED-4671-AA74-6599064A8749}"/>
              </a:ext>
            </a:extLst>
          </p:cNvPr>
          <p:cNvSpPr txBox="1"/>
          <p:nvPr/>
        </p:nvSpPr>
        <p:spPr>
          <a:xfrm>
            <a:off x="1914106" y="0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629B344-5B36-4723-871C-D35CDD5D8406}"/>
              </a:ext>
            </a:extLst>
          </p:cNvPr>
          <p:cNvSpPr txBox="1"/>
          <p:nvPr/>
        </p:nvSpPr>
        <p:spPr>
          <a:xfrm>
            <a:off x="4780395" y="0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3491F18-0ECF-4D88-ACDC-98C13486E98C}"/>
              </a:ext>
            </a:extLst>
          </p:cNvPr>
          <p:cNvSpPr txBox="1"/>
          <p:nvPr/>
        </p:nvSpPr>
        <p:spPr>
          <a:xfrm>
            <a:off x="7547247" y="0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L+EX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49BEECC-9EFA-431D-AA2C-A42AD4D83289}"/>
              </a:ext>
            </a:extLst>
          </p:cNvPr>
          <p:cNvSpPr txBox="1"/>
          <p:nvPr/>
        </p:nvSpPr>
        <p:spPr>
          <a:xfrm>
            <a:off x="111227" y="1207361"/>
            <a:ext cx="6142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∆ Rd/I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78429DA-2035-4D57-A60D-EF5694C9A9FA}"/>
              </a:ext>
            </a:extLst>
          </p:cNvPr>
          <p:cNvSpPr txBox="1"/>
          <p:nvPr/>
        </p:nvSpPr>
        <p:spPr>
          <a:xfrm>
            <a:off x="-26748" y="3275129"/>
            <a:ext cx="9893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∆ HOMA-IR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CC3B9C7-4B72-4E51-A03A-1272DC1AB6E5}"/>
              </a:ext>
            </a:extLst>
          </p:cNvPr>
          <p:cNvSpPr txBox="1"/>
          <p:nvPr/>
        </p:nvSpPr>
        <p:spPr>
          <a:xfrm>
            <a:off x="50996" y="5306864"/>
            <a:ext cx="8338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∆ HbA1C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</a:p>
        </p:txBody>
      </p:sp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3C98E212-B840-4F95-95A8-AB08F1F2CB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949" y="276999"/>
            <a:ext cx="2792210" cy="1975275"/>
          </a:xfrm>
          <a:prstGeom prst="rect">
            <a:avLst/>
          </a:prstGeom>
        </p:spPr>
      </p:pic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6053C25A-4C44-4567-B63D-08E456E53B3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767" y="2413528"/>
            <a:ext cx="2792210" cy="1975275"/>
          </a:xfrm>
          <a:prstGeom prst="rect">
            <a:avLst/>
          </a:prstGeom>
        </p:spPr>
      </p:pic>
      <p:pic>
        <p:nvPicPr>
          <p:cNvPr id="8" name="Picture 7" descr="A close up of a logo&#10;&#10;Description automatically generated">
            <a:extLst>
              <a:ext uri="{FF2B5EF4-FFF2-40B4-BE49-F238E27FC236}">
                <a16:creationId xmlns:a16="http://schemas.microsoft.com/office/drawing/2014/main" id="{14CD714C-F40A-4AB4-90C9-73ABB14E331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767" y="4550058"/>
            <a:ext cx="2792210" cy="1975275"/>
          </a:xfrm>
          <a:prstGeom prst="rect">
            <a:avLst/>
          </a:prstGeom>
        </p:spPr>
      </p:pic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9D37140E-85F9-472C-ADB9-750DC2B8B06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7573" y="276999"/>
            <a:ext cx="2786113" cy="1975275"/>
          </a:xfrm>
          <a:prstGeom prst="rect">
            <a:avLst/>
          </a:prstGeom>
        </p:spPr>
      </p:pic>
      <p:pic>
        <p:nvPicPr>
          <p:cNvPr id="12" name="Picture 11" descr="A close up of a piano&#10;&#10;Description automatically generated">
            <a:extLst>
              <a:ext uri="{FF2B5EF4-FFF2-40B4-BE49-F238E27FC236}">
                <a16:creationId xmlns:a16="http://schemas.microsoft.com/office/drawing/2014/main" id="{240E8D10-ABC7-42EC-BECF-B8A7E467236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408" y="2411840"/>
            <a:ext cx="2786113" cy="1975275"/>
          </a:xfrm>
          <a:prstGeom prst="rect">
            <a:avLst/>
          </a:prstGeom>
        </p:spPr>
      </p:pic>
      <p:pic>
        <p:nvPicPr>
          <p:cNvPr id="14" name="Picture 13" descr="A close up of a logo&#10;&#10;Description automatically generated">
            <a:extLst>
              <a:ext uri="{FF2B5EF4-FFF2-40B4-BE49-F238E27FC236}">
                <a16:creationId xmlns:a16="http://schemas.microsoft.com/office/drawing/2014/main" id="{7E34B6E6-6F65-41DB-BF0F-7842B8F2DF4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408" y="4550057"/>
            <a:ext cx="2786113" cy="1975275"/>
          </a:xfrm>
          <a:prstGeom prst="rect">
            <a:avLst/>
          </a:prstGeom>
        </p:spPr>
      </p:pic>
      <p:pic>
        <p:nvPicPr>
          <p:cNvPr id="16" name="Picture 15" descr="A close up of a logo&#10;&#10;Description automatically generated">
            <a:extLst>
              <a:ext uri="{FF2B5EF4-FFF2-40B4-BE49-F238E27FC236}">
                <a16:creationId xmlns:a16="http://schemas.microsoft.com/office/drawing/2014/main" id="{5DAC9E2E-FF0E-47B2-A08C-105998D56C3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1473" y="276999"/>
            <a:ext cx="2792210" cy="1975275"/>
          </a:xfrm>
          <a:prstGeom prst="rect">
            <a:avLst/>
          </a:prstGeom>
        </p:spPr>
      </p:pic>
      <p:pic>
        <p:nvPicPr>
          <p:cNvPr id="20" name="Picture 19" descr="A close up of a piano&#10;&#10;Description automatically generated">
            <a:extLst>
              <a:ext uri="{FF2B5EF4-FFF2-40B4-BE49-F238E27FC236}">
                <a16:creationId xmlns:a16="http://schemas.microsoft.com/office/drawing/2014/main" id="{012CC181-7CB6-470C-B2B4-E072B2B24EF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7570" y="2493311"/>
            <a:ext cx="2786113" cy="1975275"/>
          </a:xfrm>
          <a:prstGeom prst="rect">
            <a:avLst/>
          </a:prstGeom>
        </p:spPr>
      </p:pic>
      <p:pic>
        <p:nvPicPr>
          <p:cNvPr id="29" name="Picture 28" descr="A picture containing table&#10;&#10;Description automatically generated">
            <a:extLst>
              <a:ext uri="{FF2B5EF4-FFF2-40B4-BE49-F238E27FC236}">
                <a16:creationId xmlns:a16="http://schemas.microsoft.com/office/drawing/2014/main" id="{24269936-217B-4098-B26B-0779E984EE6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7887" y="4550057"/>
            <a:ext cx="2786113" cy="1975275"/>
          </a:xfrm>
          <a:prstGeom prst="rect">
            <a:avLst/>
          </a:prstGeom>
        </p:spPr>
      </p:pic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434B48F2-C477-4CAC-980E-439B38110497}"/>
              </a:ext>
            </a:extLst>
          </p:cNvPr>
          <p:cNvCxnSpPr>
            <a:cxnSpLocks/>
          </p:cNvCxnSpPr>
          <p:nvPr/>
        </p:nvCxnSpPr>
        <p:spPr>
          <a:xfrm>
            <a:off x="3573675" y="193020"/>
            <a:ext cx="0" cy="6248333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00A8E04-4DFF-4390-9977-23A19741C4F6}"/>
              </a:ext>
            </a:extLst>
          </p:cNvPr>
          <p:cNvCxnSpPr>
            <a:cxnSpLocks/>
          </p:cNvCxnSpPr>
          <p:nvPr/>
        </p:nvCxnSpPr>
        <p:spPr>
          <a:xfrm>
            <a:off x="6379373" y="202351"/>
            <a:ext cx="0" cy="6248333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F52D7222-473D-4B38-9605-5EDB4CEF67B7}"/>
              </a:ext>
            </a:extLst>
          </p:cNvPr>
          <p:cNvSpPr/>
          <p:nvPr/>
        </p:nvSpPr>
        <p:spPr>
          <a:xfrm>
            <a:off x="-43348" y="6458149"/>
            <a:ext cx="930533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.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dividual responses for the components of the C_IS score and corresponding individual’s response for each component that comprises the C_IS score. Participant responses are in the same order for each variable. For example, the first bar in each graph for a given group is the same individual.</a:t>
            </a:r>
            <a:endParaRPr lang="en-US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8410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02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NNAN, Andrea</dc:creator>
  <cp:lastModifiedBy>BRENNAN, Andrea</cp:lastModifiedBy>
  <cp:revision>3</cp:revision>
  <dcterms:created xsi:type="dcterms:W3CDTF">2020-05-26T23:56:44Z</dcterms:created>
  <dcterms:modified xsi:type="dcterms:W3CDTF">2020-07-02T17:40:10Z</dcterms:modified>
</cp:coreProperties>
</file>